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89" r:id="rId2"/>
    <p:sldId id="281" r:id="rId3"/>
    <p:sldId id="295" r:id="rId4"/>
    <p:sldId id="275" r:id="rId5"/>
    <p:sldId id="292" r:id="rId6"/>
    <p:sldId id="293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orient="horz" pos="27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D633"/>
    <a:srgbClr val="3333FF"/>
    <a:srgbClr val="FF3333"/>
    <a:srgbClr val="000000"/>
    <a:srgbClr val="2B2BFF"/>
    <a:srgbClr val="FFCCFF"/>
    <a:srgbClr val="DAE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9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26" y="282"/>
      </p:cViewPr>
      <p:guideLst>
        <p:guide orient="horz" pos="2160"/>
        <p:guide pos="2880"/>
        <p:guide orient="horz" pos="272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userId="e92235b909240927" providerId="LiveId" clId="{8DF9CDF6-84BC-4987-9B1C-7B684173BA3E}"/>
    <pc:docChg chg="undo custSel addSld delSld modSld">
      <pc:chgData name="" userId="e92235b909240927" providerId="LiveId" clId="{8DF9CDF6-84BC-4987-9B1C-7B684173BA3E}" dt="2022-04-09T05:51:27.102" v="375" actId="20577"/>
      <pc:docMkLst>
        <pc:docMk/>
      </pc:docMkLst>
      <pc:sldChg chg="modSp">
        <pc:chgData name="" userId="e92235b909240927" providerId="LiveId" clId="{8DF9CDF6-84BC-4987-9B1C-7B684173BA3E}" dt="2022-04-09T05:51:07.595" v="371" actId="20577"/>
        <pc:sldMkLst>
          <pc:docMk/>
          <pc:sldMk cId="754527677" sldId="275"/>
        </pc:sldMkLst>
        <pc:spChg chg="mod">
          <ac:chgData name="" userId="e92235b909240927" providerId="LiveId" clId="{8DF9CDF6-84BC-4987-9B1C-7B684173BA3E}" dt="2022-04-09T05:51:07.595" v="371" actId="20577"/>
          <ac:spMkLst>
            <pc:docMk/>
            <pc:sldMk cId="754527677" sldId="275"/>
            <ac:spMk id="2" creationId="{00000000-0000-0000-0000-000000000000}"/>
          </ac:spMkLst>
        </pc:spChg>
        <pc:spChg chg="mod">
          <ac:chgData name="" userId="e92235b909240927" providerId="LiveId" clId="{8DF9CDF6-84BC-4987-9B1C-7B684173BA3E}" dt="2022-04-09T05:42:44.448" v="283" actId="1038"/>
          <ac:spMkLst>
            <pc:docMk/>
            <pc:sldMk cId="754527677" sldId="275"/>
            <ac:spMk id="3" creationId="{00000000-0000-0000-0000-000000000000}"/>
          </ac:spMkLst>
        </pc:spChg>
        <pc:graphicFrameChg chg="mod modGraphic">
          <ac:chgData name="" userId="e92235b909240927" providerId="LiveId" clId="{8DF9CDF6-84BC-4987-9B1C-7B684173BA3E}" dt="2022-04-09T05:43:36.208" v="289" actId="242"/>
          <ac:graphicFrameMkLst>
            <pc:docMk/>
            <pc:sldMk cId="754527677" sldId="275"/>
            <ac:graphicFrameMk id="11" creationId="{CBD5CEC3-942A-4C79-BF39-325A8C678DD0}"/>
          </ac:graphicFrameMkLst>
        </pc:graphicFrameChg>
      </pc:sldChg>
      <pc:sldChg chg="del">
        <pc:chgData name="" userId="e92235b909240927" providerId="LiveId" clId="{8DF9CDF6-84BC-4987-9B1C-7B684173BA3E}" dt="2022-04-09T05:43:57.518" v="293" actId="2696"/>
        <pc:sldMkLst>
          <pc:docMk/>
          <pc:sldMk cId="2300715405" sldId="276"/>
        </pc:sldMkLst>
      </pc:sldChg>
      <pc:sldChg chg="del">
        <pc:chgData name="" userId="e92235b909240927" providerId="LiveId" clId="{8DF9CDF6-84BC-4987-9B1C-7B684173BA3E}" dt="2022-04-09T05:44:08.249" v="297" actId="2696"/>
        <pc:sldMkLst>
          <pc:docMk/>
          <pc:sldMk cId="644382241" sldId="277"/>
        </pc:sldMkLst>
      </pc:sldChg>
      <pc:sldChg chg="del">
        <pc:chgData name="" userId="e92235b909240927" providerId="LiveId" clId="{8DF9CDF6-84BC-4987-9B1C-7B684173BA3E}" dt="2022-04-09T05:41:37.660" v="256" actId="2696"/>
        <pc:sldMkLst>
          <pc:docMk/>
          <pc:sldMk cId="760549776" sldId="278"/>
        </pc:sldMkLst>
      </pc:sldChg>
      <pc:sldChg chg="del">
        <pc:chgData name="" userId="e92235b909240927" providerId="LiveId" clId="{8DF9CDF6-84BC-4987-9B1C-7B684173BA3E}" dt="2022-04-09T05:41:57.874" v="259" actId="2696"/>
        <pc:sldMkLst>
          <pc:docMk/>
          <pc:sldMk cId="3928790629" sldId="279"/>
        </pc:sldMkLst>
      </pc:sldChg>
      <pc:sldChg chg="modSp">
        <pc:chgData name="" userId="e92235b909240927" providerId="LiveId" clId="{8DF9CDF6-84BC-4987-9B1C-7B684173BA3E}" dt="2022-04-09T05:50:56.229" v="369"/>
        <pc:sldMkLst>
          <pc:docMk/>
          <pc:sldMk cId="2090605893" sldId="281"/>
        </pc:sldMkLst>
        <pc:spChg chg="mod">
          <ac:chgData name="" userId="e92235b909240927" providerId="LiveId" clId="{8DF9CDF6-84BC-4987-9B1C-7B684173BA3E}" dt="2022-04-09T05:50:56.229" v="369"/>
          <ac:spMkLst>
            <pc:docMk/>
            <pc:sldMk cId="2090605893" sldId="281"/>
            <ac:spMk id="12" creationId="{00000000-0000-0000-0000-000000000000}"/>
          </ac:spMkLst>
        </pc:spChg>
      </pc:sldChg>
      <pc:sldChg chg="addSp delSp modSp">
        <pc:chgData name="" userId="e92235b909240927" providerId="LiveId" clId="{8DF9CDF6-84BC-4987-9B1C-7B684173BA3E}" dt="2022-04-09T05:45:15.795" v="304" actId="1036"/>
        <pc:sldMkLst>
          <pc:docMk/>
          <pc:sldMk cId="1587945973" sldId="288"/>
        </pc:sldMkLst>
        <pc:spChg chg="add mod ord">
          <ac:chgData name="" userId="e92235b909240927" providerId="LiveId" clId="{8DF9CDF6-84BC-4987-9B1C-7B684173BA3E}" dt="2022-04-09T05:37:14.618" v="76" actId="1038"/>
          <ac:spMkLst>
            <pc:docMk/>
            <pc:sldMk cId="1587945973" sldId="288"/>
            <ac:spMk id="2" creationId="{6BFE88C5-B7B2-4361-97A4-4BD018D5FE6B}"/>
          </ac:spMkLst>
        </pc:spChg>
        <pc:spChg chg="mod">
          <ac:chgData name="" userId="e92235b909240927" providerId="LiveId" clId="{8DF9CDF6-84BC-4987-9B1C-7B684173BA3E}" dt="2022-04-09T05:45:08.085" v="303" actId="1036"/>
          <ac:spMkLst>
            <pc:docMk/>
            <pc:sldMk cId="1587945973" sldId="288"/>
            <ac:spMk id="21" creationId="{BB68903D-671E-4203-9856-336846C879A7}"/>
          </ac:spMkLst>
        </pc:spChg>
        <pc:spChg chg="mod">
          <ac:chgData name="" userId="e92235b909240927" providerId="LiveId" clId="{8DF9CDF6-84BC-4987-9B1C-7B684173BA3E}" dt="2022-04-09T05:34:40.722" v="23" actId="1036"/>
          <ac:spMkLst>
            <pc:docMk/>
            <pc:sldMk cId="1587945973" sldId="288"/>
            <ac:spMk id="23" creationId="{3185CF18-6AA5-40A7-AC3C-757DE352076F}"/>
          </ac:spMkLst>
        </pc:spChg>
        <pc:spChg chg="mod">
          <ac:chgData name="" userId="e92235b909240927" providerId="LiveId" clId="{8DF9CDF6-84BC-4987-9B1C-7B684173BA3E}" dt="2022-04-09T05:38:50.252" v="133" actId="1036"/>
          <ac:spMkLst>
            <pc:docMk/>
            <pc:sldMk cId="1587945973" sldId="288"/>
            <ac:spMk id="24" creationId="{6F3BCD85-701F-4BB7-B996-09BE4E9B8491}"/>
          </ac:spMkLst>
        </pc:spChg>
        <pc:spChg chg="mod">
          <ac:chgData name="" userId="e92235b909240927" providerId="LiveId" clId="{8DF9CDF6-84BC-4987-9B1C-7B684173BA3E}" dt="2022-04-09T05:45:15.795" v="304" actId="1036"/>
          <ac:spMkLst>
            <pc:docMk/>
            <pc:sldMk cId="1587945973" sldId="288"/>
            <ac:spMk id="25" creationId="{979DEC15-C5EC-4688-B155-F5F376A37203}"/>
          </ac:spMkLst>
        </pc:spChg>
        <pc:spChg chg="add mod ord">
          <ac:chgData name="" userId="e92235b909240927" providerId="LiveId" clId="{8DF9CDF6-84BC-4987-9B1C-7B684173BA3E}" dt="2022-04-09T05:36:59.120" v="72" actId="1036"/>
          <ac:spMkLst>
            <pc:docMk/>
            <pc:sldMk cId="1587945973" sldId="288"/>
            <ac:spMk id="33" creationId="{E6289655-B447-4832-AA12-EF7883484B58}"/>
          </ac:spMkLst>
        </pc:spChg>
        <pc:spChg chg="add del">
          <ac:chgData name="" userId="e92235b909240927" providerId="LiveId" clId="{8DF9CDF6-84BC-4987-9B1C-7B684173BA3E}" dt="2022-04-09T05:37:22.418" v="78"/>
          <ac:spMkLst>
            <pc:docMk/>
            <pc:sldMk cId="1587945973" sldId="288"/>
            <ac:spMk id="34" creationId="{3BBF7908-7718-4019-91CD-B544DB900B19}"/>
          </ac:spMkLst>
        </pc:spChg>
        <pc:spChg chg="add del">
          <ac:chgData name="" userId="e92235b909240927" providerId="LiveId" clId="{8DF9CDF6-84BC-4987-9B1C-7B684173BA3E}" dt="2022-04-09T05:37:22.418" v="78"/>
          <ac:spMkLst>
            <pc:docMk/>
            <pc:sldMk cId="1587945973" sldId="288"/>
            <ac:spMk id="35" creationId="{F7A4918D-9E76-4363-8B2B-50EDD77BAA02}"/>
          </ac:spMkLst>
        </pc:spChg>
        <pc:spChg chg="add mod ord">
          <ac:chgData name="" userId="e92235b909240927" providerId="LiveId" clId="{8DF9CDF6-84BC-4987-9B1C-7B684173BA3E}" dt="2022-04-09T05:38:38.053" v="117" actId="167"/>
          <ac:spMkLst>
            <pc:docMk/>
            <pc:sldMk cId="1587945973" sldId="288"/>
            <ac:spMk id="37" creationId="{19FC307C-F645-448E-A358-5FB9260B9644}"/>
          </ac:spMkLst>
        </pc:spChg>
        <pc:spChg chg="add mod ord">
          <ac:chgData name="" userId="e92235b909240927" providerId="LiveId" clId="{8DF9CDF6-84BC-4987-9B1C-7B684173BA3E}" dt="2022-04-09T05:38:38.053" v="117" actId="167"/>
          <ac:spMkLst>
            <pc:docMk/>
            <pc:sldMk cId="1587945973" sldId="288"/>
            <ac:spMk id="38" creationId="{9E697642-C918-4890-9406-D37A8E32BD1E}"/>
          </ac:spMkLst>
        </pc:spChg>
        <pc:spChg chg="add del mod">
          <ac:chgData name="" userId="e92235b909240927" providerId="LiveId" clId="{8DF9CDF6-84BC-4987-9B1C-7B684173BA3E}" dt="2022-04-09T05:39:29.219" v="173"/>
          <ac:spMkLst>
            <pc:docMk/>
            <pc:sldMk cId="1587945973" sldId="288"/>
            <ac:spMk id="41" creationId="{DFA565A7-7D94-4BB6-B5FD-65CFE304A064}"/>
          </ac:spMkLst>
        </pc:spChg>
        <pc:spChg chg="add del mod">
          <ac:chgData name="" userId="e92235b909240927" providerId="LiveId" clId="{8DF9CDF6-84BC-4987-9B1C-7B684173BA3E}" dt="2022-04-09T05:39:29.219" v="173"/>
          <ac:spMkLst>
            <pc:docMk/>
            <pc:sldMk cId="1587945973" sldId="288"/>
            <ac:spMk id="42" creationId="{A8944C03-58A7-41DB-985C-8EA3AB124940}"/>
          </ac:spMkLst>
        </pc:spChg>
        <pc:spChg chg="add mod ord">
          <ac:chgData name="" userId="e92235b909240927" providerId="LiveId" clId="{8DF9CDF6-84BC-4987-9B1C-7B684173BA3E}" dt="2022-04-09T05:40:53.223" v="233" actId="167"/>
          <ac:spMkLst>
            <pc:docMk/>
            <pc:sldMk cId="1587945973" sldId="288"/>
            <ac:spMk id="44" creationId="{C4EE0C92-9DA3-4898-BE63-F4A59C6A7980}"/>
          </ac:spMkLst>
        </pc:spChg>
        <pc:spChg chg="add mod ord">
          <ac:chgData name="" userId="e92235b909240927" providerId="LiveId" clId="{8DF9CDF6-84BC-4987-9B1C-7B684173BA3E}" dt="2022-04-09T05:40:53.223" v="233" actId="167"/>
          <ac:spMkLst>
            <pc:docMk/>
            <pc:sldMk cId="1587945973" sldId="288"/>
            <ac:spMk id="45" creationId="{EDFCC7F7-99DC-4D09-A069-2392E57FC752}"/>
          </ac:spMkLst>
        </pc:spChg>
        <pc:picChg chg="mod modCrop">
          <ac:chgData name="" userId="e92235b909240927" providerId="LiveId" clId="{8DF9CDF6-84BC-4987-9B1C-7B684173BA3E}" dt="2022-04-09T05:33:53.050" v="0" actId="732"/>
          <ac:picMkLst>
            <pc:docMk/>
            <pc:sldMk cId="1587945973" sldId="288"/>
            <ac:picMk id="4" creationId="{00000000-0000-0000-0000-000000000000}"/>
          </ac:picMkLst>
        </pc:picChg>
        <pc:picChg chg="mod modCrop">
          <ac:chgData name="" userId="e92235b909240927" providerId="LiveId" clId="{8DF9CDF6-84BC-4987-9B1C-7B684173BA3E}" dt="2022-04-09T05:34:15.484" v="2" actId="1076"/>
          <ac:picMkLst>
            <pc:docMk/>
            <pc:sldMk cId="1587945973" sldId="288"/>
            <ac:picMk id="5" creationId="{00000000-0000-0000-0000-000000000000}"/>
          </ac:picMkLst>
        </pc:picChg>
        <pc:picChg chg="mod modCrop">
          <ac:chgData name="" userId="e92235b909240927" providerId="LiveId" clId="{8DF9CDF6-84BC-4987-9B1C-7B684173BA3E}" dt="2022-04-09T05:39:51.459" v="198" actId="1036"/>
          <ac:picMkLst>
            <pc:docMk/>
            <pc:sldMk cId="1587945973" sldId="288"/>
            <ac:picMk id="7" creationId="{00000000-0000-0000-0000-000000000000}"/>
          </ac:picMkLst>
        </pc:picChg>
        <pc:picChg chg="mod">
          <ac:chgData name="" userId="e92235b909240927" providerId="LiveId" clId="{8DF9CDF6-84BC-4987-9B1C-7B684173BA3E}" dt="2022-04-09T05:41:09.615" v="255" actId="1076"/>
          <ac:picMkLst>
            <pc:docMk/>
            <pc:sldMk cId="1587945973" sldId="288"/>
            <ac:picMk id="31" creationId="{00000000-0000-0000-0000-000000000000}"/>
          </ac:picMkLst>
        </pc:picChg>
        <pc:picChg chg="add del mod">
          <ac:chgData name="" userId="e92235b909240927" providerId="LiveId" clId="{8DF9CDF6-84BC-4987-9B1C-7B684173BA3E}" dt="2022-04-09T05:37:02.617" v="73" actId="478"/>
          <ac:picMkLst>
            <pc:docMk/>
            <pc:sldMk cId="1587945973" sldId="288"/>
            <ac:picMk id="32" creationId="{512C8CF8-D2FD-41D0-8831-94C11535224E}"/>
          </ac:picMkLst>
        </pc:picChg>
        <pc:picChg chg="add del">
          <ac:chgData name="" userId="e92235b909240927" providerId="LiveId" clId="{8DF9CDF6-84BC-4987-9B1C-7B684173BA3E}" dt="2022-04-09T05:37:22.418" v="78"/>
          <ac:picMkLst>
            <pc:docMk/>
            <pc:sldMk cId="1587945973" sldId="288"/>
            <ac:picMk id="36" creationId="{EA3FA450-10CC-43B5-A144-943FDEDF93D1}"/>
          </ac:picMkLst>
        </pc:picChg>
        <pc:picChg chg="add del mod">
          <ac:chgData name="" userId="e92235b909240927" providerId="LiveId" clId="{8DF9CDF6-84BC-4987-9B1C-7B684173BA3E}" dt="2022-04-09T05:38:53.184" v="134" actId="478"/>
          <ac:picMkLst>
            <pc:docMk/>
            <pc:sldMk cId="1587945973" sldId="288"/>
            <ac:picMk id="39" creationId="{73EE2886-A10F-46BF-AA13-28560556953C}"/>
          </ac:picMkLst>
        </pc:picChg>
        <pc:picChg chg="add del mod">
          <ac:chgData name="" userId="e92235b909240927" providerId="LiveId" clId="{8DF9CDF6-84BC-4987-9B1C-7B684173BA3E}" dt="2022-04-09T05:41:04.183" v="254" actId="478"/>
          <ac:picMkLst>
            <pc:docMk/>
            <pc:sldMk cId="1587945973" sldId="288"/>
            <ac:picMk id="40" creationId="{44F93FBD-C0B3-487B-8711-3F10C2F7C432}"/>
          </ac:picMkLst>
        </pc:picChg>
        <pc:picChg chg="add del mod">
          <ac:chgData name="" userId="e92235b909240927" providerId="LiveId" clId="{8DF9CDF6-84BC-4987-9B1C-7B684173BA3E}" dt="2022-04-09T05:39:29.219" v="173"/>
          <ac:picMkLst>
            <pc:docMk/>
            <pc:sldMk cId="1587945973" sldId="288"/>
            <ac:picMk id="43" creationId="{2284E6B9-5065-4365-868A-23152C065BA1}"/>
          </ac:picMkLst>
        </pc:picChg>
      </pc:sldChg>
      <pc:sldChg chg="add">
        <pc:chgData name="" userId="e92235b909240927" providerId="LiveId" clId="{8DF9CDF6-84BC-4987-9B1C-7B684173BA3E}" dt="2022-04-09T05:41:39.501" v="257"/>
        <pc:sldMkLst>
          <pc:docMk/>
          <pc:sldMk cId="234569446" sldId="290"/>
        </pc:sldMkLst>
      </pc:sldChg>
      <pc:sldChg chg="add">
        <pc:chgData name="" userId="e92235b909240927" providerId="LiveId" clId="{8DF9CDF6-84BC-4987-9B1C-7B684173BA3E}" dt="2022-04-09T05:41:56.104" v="258"/>
        <pc:sldMkLst>
          <pc:docMk/>
          <pc:sldMk cId="3519271162" sldId="291"/>
        </pc:sldMkLst>
      </pc:sldChg>
      <pc:sldChg chg="modSp add del">
        <pc:chgData name="" userId="e92235b909240927" providerId="LiveId" clId="{8DF9CDF6-84BC-4987-9B1C-7B684173BA3E}" dt="2022-04-09T05:51:18.091" v="373" actId="20577"/>
        <pc:sldMkLst>
          <pc:docMk/>
          <pc:sldMk cId="980394872" sldId="292"/>
        </pc:sldMkLst>
        <pc:spChg chg="mod">
          <ac:chgData name="" userId="e92235b909240927" providerId="LiveId" clId="{8DF9CDF6-84BC-4987-9B1C-7B684173BA3E}" dt="2022-04-09T05:51:18.091" v="373" actId="20577"/>
          <ac:spMkLst>
            <pc:docMk/>
            <pc:sldMk cId="980394872" sldId="292"/>
            <ac:spMk id="5" creationId="{00000000-0000-0000-0000-000000000000}"/>
          </ac:spMkLst>
        </pc:spChg>
      </pc:sldChg>
      <pc:sldChg chg="addSp modSp add del">
        <pc:chgData name="" userId="e92235b909240927" providerId="LiveId" clId="{8DF9CDF6-84BC-4987-9B1C-7B684173BA3E}" dt="2022-04-09T05:51:27.102" v="375" actId="20577"/>
        <pc:sldMkLst>
          <pc:docMk/>
          <pc:sldMk cId="2690845886" sldId="293"/>
        </pc:sldMkLst>
        <pc:spChg chg="mod">
          <ac:chgData name="" userId="e92235b909240927" providerId="LiveId" clId="{8DF9CDF6-84BC-4987-9B1C-7B684173BA3E}" dt="2022-04-09T05:51:27.102" v="375" actId="20577"/>
          <ac:spMkLst>
            <pc:docMk/>
            <pc:sldMk cId="2690845886" sldId="293"/>
            <ac:spMk id="6" creationId="{00000000-0000-0000-0000-000000000000}"/>
          </ac:spMkLst>
        </pc:spChg>
        <pc:spChg chg="mod">
          <ac:chgData name="" userId="e92235b909240927" providerId="LiveId" clId="{8DF9CDF6-84BC-4987-9B1C-7B684173BA3E}" dt="2022-04-09T05:46:36.683" v="368" actId="1036"/>
          <ac:spMkLst>
            <pc:docMk/>
            <pc:sldMk cId="2690845886" sldId="293"/>
            <ac:spMk id="11" creationId="{BCC8A4A1-63DF-4E36-8FDF-BF685372841B}"/>
          </ac:spMkLst>
        </pc:spChg>
        <pc:spChg chg="mod">
          <ac:chgData name="" userId="e92235b909240927" providerId="LiveId" clId="{8DF9CDF6-84BC-4987-9B1C-7B684173BA3E}" dt="2022-04-09T05:46:36.683" v="368" actId="1036"/>
          <ac:spMkLst>
            <pc:docMk/>
            <pc:sldMk cId="2690845886" sldId="293"/>
            <ac:spMk id="12" creationId="{5C745D91-C8BC-47BE-8E35-7983D1D6B360}"/>
          </ac:spMkLst>
        </pc:spChg>
        <pc:spChg chg="add mod ord">
          <ac:chgData name="" userId="e92235b909240927" providerId="LiveId" clId="{8DF9CDF6-84BC-4987-9B1C-7B684173BA3E}" dt="2022-04-09T05:46:26.483" v="344" actId="14100"/>
          <ac:spMkLst>
            <pc:docMk/>
            <pc:sldMk cId="2690845886" sldId="293"/>
            <ac:spMk id="13" creationId="{E728C6D0-8A8E-4C8F-8177-31789F56E5E7}"/>
          </ac:spMkLst>
        </pc:spChg>
        <pc:spChg chg="add mod ord">
          <ac:chgData name="" userId="e92235b909240927" providerId="LiveId" clId="{8DF9CDF6-84BC-4987-9B1C-7B684173BA3E}" dt="2022-04-09T05:46:26.483" v="344" actId="14100"/>
          <ac:spMkLst>
            <pc:docMk/>
            <pc:sldMk cId="2690845886" sldId="293"/>
            <ac:spMk id="14" creationId="{2366DD27-3229-4BDC-8E66-15004A1011C5}"/>
          </ac:spMkLst>
        </pc:spChg>
        <pc:picChg chg="mod modCrop">
          <ac:chgData name="" userId="e92235b909240927" providerId="LiveId" clId="{8DF9CDF6-84BC-4987-9B1C-7B684173BA3E}" dt="2022-04-09T05:45:58.306" v="310" actId="732"/>
          <ac:picMkLst>
            <pc:docMk/>
            <pc:sldMk cId="2690845886" sldId="293"/>
            <ac:picMk id="2" creationId="{00000000-0000-0000-0000-000000000000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n-Ui%20Bae\Dropbox\Kwon\KD%20&#44277;&#46041;&#50672;&#44396;\INS%20MGN%20&#48152;&#51025;&#49457;&#47560;&#52964;\Exosome_miRNA_&#44536;&#47000;&#54532;_K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전체!$AD$103</c:f>
              <c:strCache>
                <c:ptCount val="1"/>
                <c:pt idx="0">
                  <c:v>miRN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전체!$AE$102:$AG$102</c:f>
              <c:strCache>
                <c:ptCount val="3"/>
                <c:pt idx="0">
                  <c:v>HV</c:v>
                </c:pt>
                <c:pt idx="1">
                  <c:v>IMN-W</c:v>
                </c:pt>
                <c:pt idx="2">
                  <c:v>IMN-R</c:v>
                </c:pt>
              </c:strCache>
            </c:strRef>
          </c:cat>
          <c:val>
            <c:numRef>
              <c:f>전체!$AE$103:$AG$103</c:f>
              <c:numCache>
                <c:formatCode>0.0</c:formatCode>
                <c:ptCount val="3"/>
                <c:pt idx="0">
                  <c:v>59.809543820716144</c:v>
                </c:pt>
                <c:pt idx="1">
                  <c:v>55.027490049690641</c:v>
                </c:pt>
                <c:pt idx="2">
                  <c:v>37.6311443001758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089-4159-B4DF-A4865F31F878}"/>
            </c:ext>
          </c:extLst>
        </c:ser>
        <c:ser>
          <c:idx val="1"/>
          <c:order val="1"/>
          <c:tx>
            <c:strRef>
              <c:f>전체!$AD$104</c:f>
              <c:strCache>
                <c:ptCount val="1"/>
                <c:pt idx="0">
                  <c:v>piRNA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전체!$AE$102:$AG$102</c:f>
              <c:strCache>
                <c:ptCount val="3"/>
                <c:pt idx="0">
                  <c:v>HV</c:v>
                </c:pt>
                <c:pt idx="1">
                  <c:v>IMN-W</c:v>
                </c:pt>
                <c:pt idx="2">
                  <c:v>IMN-R</c:v>
                </c:pt>
              </c:strCache>
            </c:strRef>
          </c:cat>
          <c:val>
            <c:numRef>
              <c:f>전체!$AE$104:$AG$104</c:f>
              <c:numCache>
                <c:formatCode>0.0</c:formatCode>
                <c:ptCount val="3"/>
                <c:pt idx="0">
                  <c:v>1.9494653734360732</c:v>
                </c:pt>
                <c:pt idx="1">
                  <c:v>1.8661205931797222</c:v>
                </c:pt>
                <c:pt idx="2">
                  <c:v>2.21827107621495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089-4159-B4DF-A4865F31F878}"/>
            </c:ext>
          </c:extLst>
        </c:ser>
        <c:ser>
          <c:idx val="2"/>
          <c:order val="2"/>
          <c:tx>
            <c:strRef>
              <c:f>전체!$AD$105</c:f>
              <c:strCache>
                <c:ptCount val="1"/>
                <c:pt idx="0">
                  <c:v>snoRN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전체!$AE$102:$AG$102</c:f>
              <c:strCache>
                <c:ptCount val="3"/>
                <c:pt idx="0">
                  <c:v>HV</c:v>
                </c:pt>
                <c:pt idx="1">
                  <c:v>IMN-W</c:v>
                </c:pt>
                <c:pt idx="2">
                  <c:v>IMN-R</c:v>
                </c:pt>
              </c:strCache>
            </c:strRef>
          </c:cat>
          <c:val>
            <c:numRef>
              <c:f>전체!$AE$105:$AG$105</c:f>
              <c:numCache>
                <c:formatCode>0.0</c:formatCode>
                <c:ptCount val="3"/>
                <c:pt idx="0">
                  <c:v>11.141663275589208</c:v>
                </c:pt>
                <c:pt idx="1">
                  <c:v>12.685388784126571</c:v>
                </c:pt>
                <c:pt idx="2">
                  <c:v>21.22007124012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089-4159-B4DF-A4865F31F878}"/>
            </c:ext>
          </c:extLst>
        </c:ser>
        <c:ser>
          <c:idx val="3"/>
          <c:order val="3"/>
          <c:tx>
            <c:strRef>
              <c:f>전체!$AD$106</c:f>
              <c:strCache>
                <c:ptCount val="1"/>
                <c:pt idx="0">
                  <c:v>snRNA</c:v>
                </c:pt>
              </c:strCache>
            </c:strRef>
          </c:tx>
          <c:spPr>
            <a:solidFill>
              <a:srgbClr val="CC99F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전체!$AE$102:$AG$102</c:f>
              <c:strCache>
                <c:ptCount val="3"/>
                <c:pt idx="0">
                  <c:v>HV</c:v>
                </c:pt>
                <c:pt idx="1">
                  <c:v>IMN-W</c:v>
                </c:pt>
                <c:pt idx="2">
                  <c:v>IMN-R</c:v>
                </c:pt>
              </c:strCache>
            </c:strRef>
          </c:cat>
          <c:val>
            <c:numRef>
              <c:f>전체!$AE$106:$AG$106</c:f>
              <c:numCache>
                <c:formatCode>0.0</c:formatCode>
                <c:ptCount val="3"/>
                <c:pt idx="0">
                  <c:v>7.6568233197456994</c:v>
                </c:pt>
                <c:pt idx="1">
                  <c:v>9.5024032742738278</c:v>
                </c:pt>
                <c:pt idx="2">
                  <c:v>14.1984675706597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089-4159-B4DF-A4865F31F878}"/>
            </c:ext>
          </c:extLst>
        </c:ser>
        <c:ser>
          <c:idx val="4"/>
          <c:order val="4"/>
          <c:tx>
            <c:strRef>
              <c:f>전체!$AD$107</c:f>
              <c:strCache>
                <c:ptCount val="1"/>
                <c:pt idx="0">
                  <c:v>tRNA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전체!$AE$102:$AG$102</c:f>
              <c:strCache>
                <c:ptCount val="3"/>
                <c:pt idx="0">
                  <c:v>HV</c:v>
                </c:pt>
                <c:pt idx="1">
                  <c:v>IMN-W</c:v>
                </c:pt>
                <c:pt idx="2">
                  <c:v>IMN-R</c:v>
                </c:pt>
              </c:strCache>
            </c:strRef>
          </c:cat>
          <c:val>
            <c:numRef>
              <c:f>전체!$AE$107:$AG$107</c:f>
              <c:numCache>
                <c:formatCode>0.0</c:formatCode>
                <c:ptCount val="3"/>
                <c:pt idx="0">
                  <c:v>16.607427086840261</c:v>
                </c:pt>
                <c:pt idx="1">
                  <c:v>15.877736363657148</c:v>
                </c:pt>
                <c:pt idx="2">
                  <c:v>22.4969256815454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2089-4159-B4DF-A4865F31F878}"/>
            </c:ext>
          </c:extLst>
        </c:ser>
        <c:ser>
          <c:idx val="5"/>
          <c:order val="5"/>
          <c:tx>
            <c:strRef>
              <c:f>전체!$AD$108</c:f>
              <c:strCache>
                <c:ptCount val="1"/>
                <c:pt idx="0">
                  <c:v>YRN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전체!$AE$102:$AG$102</c:f>
              <c:strCache>
                <c:ptCount val="3"/>
                <c:pt idx="0">
                  <c:v>HV</c:v>
                </c:pt>
                <c:pt idx="1">
                  <c:v>IMN-W</c:v>
                </c:pt>
                <c:pt idx="2">
                  <c:v>IMN-R</c:v>
                </c:pt>
              </c:strCache>
            </c:strRef>
          </c:cat>
          <c:val>
            <c:numRef>
              <c:f>전체!$AE$108:$AG$108</c:f>
              <c:numCache>
                <c:formatCode>0.0</c:formatCode>
                <c:ptCount val="3"/>
                <c:pt idx="0">
                  <c:v>2.8748217608105628</c:v>
                </c:pt>
                <c:pt idx="1">
                  <c:v>5.1120826112178985</c:v>
                </c:pt>
                <c:pt idx="2">
                  <c:v>2.13606326267153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2089-4159-B4DF-A4865F31F8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100"/>
        <c:axId val="14639728"/>
        <c:axId val="14645712"/>
      </c:barChart>
      <c:catAx>
        <c:axId val="14639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45712"/>
        <c:crosses val="autoZero"/>
        <c:auto val="1"/>
        <c:lblAlgn val="ctr"/>
        <c:lblOffset val="100"/>
        <c:noMultiLvlLbl val="0"/>
      </c:catAx>
      <c:valAx>
        <c:axId val="146457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1"/>
        <c:majorTickMark val="in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3972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6437FD-5C4A-4A4F-BB67-08B22254CDC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59F619-78AA-4F3F-B2D3-DEDEA6D836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0186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3467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3497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7342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7760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4514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913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2191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7041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9458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643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3990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A8F38-01BF-46ED-BF9A-2DC432843364}" type="datetimeFigureOut">
              <a:rPr lang="ko-KR" altLang="en-US" smtClean="0"/>
              <a:t>2022-05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28834-61EF-4238-91D8-169D245E01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81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66415" y="12372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75285" y="1222128"/>
            <a:ext cx="2604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r="7473"/>
          <a:stretch/>
        </p:blipFill>
        <p:spPr>
          <a:xfrm>
            <a:off x="1415255" y="1608869"/>
            <a:ext cx="2954521" cy="277026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3"/>
          <a:srcRect r="8203"/>
          <a:stretch/>
        </p:blipFill>
        <p:spPr>
          <a:xfrm>
            <a:off x="4630243" y="1608869"/>
            <a:ext cx="2973477" cy="275717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1415255" y="4476107"/>
            <a:ext cx="618846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350" dirty="0">
                <a:latin typeface="Arial" panose="020B0604020202020204" pitchFamily="34" charset="0"/>
                <a:cs typeface="Arial" panose="020B0604020202020204" pitchFamily="34" charset="0"/>
              </a:rPr>
              <a:t>    A; </a:t>
            </a:r>
            <a:r>
              <a:rPr lang="en-US" altLang="ko-KR" sz="1350" dirty="0" err="1">
                <a:latin typeface="Arial" panose="020B0604020202020204" pitchFamily="34" charset="0"/>
                <a:cs typeface="Arial" panose="020B0604020202020204" pitchFamily="34" charset="0"/>
              </a:rPr>
              <a:t>Bioanalyzer</a:t>
            </a:r>
            <a:r>
              <a:rPr lang="en-US" altLang="ko-KR" sz="13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350" dirty="0" err="1">
                <a:latin typeface="Arial" panose="020B0604020202020204" pitchFamily="34" charset="0"/>
                <a:cs typeface="Arial" panose="020B0604020202020204" pitchFamily="34" charset="0"/>
              </a:rPr>
              <a:t>pico</a:t>
            </a:r>
            <a:r>
              <a:rPr lang="en-US" altLang="ko-KR" sz="1350" dirty="0">
                <a:latin typeface="Arial" panose="020B0604020202020204" pitchFamily="34" charset="0"/>
                <a:cs typeface="Arial" panose="020B0604020202020204" pitchFamily="34" charset="0"/>
              </a:rPr>
              <a:t> 6000 chip                     B; </a:t>
            </a:r>
            <a:r>
              <a:rPr lang="en-US" altLang="ko-KR" sz="1350" dirty="0" err="1">
                <a:latin typeface="Arial" panose="020B0604020202020204" pitchFamily="34" charset="0"/>
                <a:cs typeface="Arial" panose="020B0604020202020204" pitchFamily="34" charset="0"/>
              </a:rPr>
              <a:t>Bioanalyzer</a:t>
            </a:r>
            <a:r>
              <a:rPr lang="en-US" altLang="ko-KR" sz="1350" dirty="0">
                <a:latin typeface="Arial" panose="020B0604020202020204" pitchFamily="34" charset="0"/>
                <a:cs typeface="Arial" panose="020B0604020202020204" pitchFamily="34" charset="0"/>
              </a:rPr>
              <a:t> small RNA chip</a:t>
            </a:r>
            <a:endParaRPr lang="ko-KR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제목 1"/>
          <p:cNvSpPr txBox="1">
            <a:spLocks/>
          </p:cNvSpPr>
          <p:nvPr/>
        </p:nvSpPr>
        <p:spPr>
          <a:xfrm>
            <a:off x="628650" y="146724"/>
            <a:ext cx="7886700" cy="70687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1</a:t>
            </a:r>
            <a:endParaRPr lang="ko-KR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3575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8298515"/>
              </p:ext>
            </p:extLst>
          </p:nvPr>
        </p:nvGraphicFramePr>
        <p:xfrm>
          <a:off x="878061" y="1638300"/>
          <a:ext cx="3028788" cy="37885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591931" y="4092481"/>
            <a:ext cx="326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**</a:t>
            </a:r>
            <a:endParaRPr lang="ko-KR" altLang="en-US" sz="1050" dirty="0"/>
          </a:p>
        </p:txBody>
      </p:sp>
      <p:sp>
        <p:nvSpPr>
          <p:cNvPr id="5" name="TextBox 4"/>
          <p:cNvSpPr txBox="1"/>
          <p:nvPr/>
        </p:nvSpPr>
        <p:spPr>
          <a:xfrm>
            <a:off x="3591931" y="3127641"/>
            <a:ext cx="3193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**</a:t>
            </a:r>
            <a:endParaRPr lang="ko-KR" altLang="en-US" sz="1050" dirty="0"/>
          </a:p>
        </p:txBody>
      </p:sp>
      <p:sp>
        <p:nvSpPr>
          <p:cNvPr id="6" name="TextBox 5"/>
          <p:cNvSpPr txBox="1"/>
          <p:nvPr/>
        </p:nvSpPr>
        <p:spPr>
          <a:xfrm>
            <a:off x="3591931" y="2572516"/>
            <a:ext cx="41220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**</a:t>
            </a:r>
            <a:endParaRPr lang="ko-KR" altLang="en-US" sz="1050" dirty="0"/>
          </a:p>
        </p:txBody>
      </p:sp>
      <p:sp>
        <p:nvSpPr>
          <p:cNvPr id="7" name="TextBox 6"/>
          <p:cNvSpPr txBox="1"/>
          <p:nvPr/>
        </p:nvSpPr>
        <p:spPr>
          <a:xfrm>
            <a:off x="3591931" y="2731013"/>
            <a:ext cx="59609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†††</a:t>
            </a:r>
            <a:endParaRPr lang="ko-KR" altLang="en-US" sz="1050" dirty="0"/>
          </a:p>
        </p:txBody>
      </p:sp>
      <p:sp>
        <p:nvSpPr>
          <p:cNvPr id="8" name="TextBox 7"/>
          <p:cNvSpPr txBox="1"/>
          <p:nvPr/>
        </p:nvSpPr>
        <p:spPr>
          <a:xfrm>
            <a:off x="3591931" y="3279571"/>
            <a:ext cx="54266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†††</a:t>
            </a:r>
            <a:endParaRPr lang="ko-KR" altLang="en-US" sz="1050" dirty="0"/>
          </a:p>
        </p:txBody>
      </p:sp>
      <p:sp>
        <p:nvSpPr>
          <p:cNvPr id="9" name="TextBox 8"/>
          <p:cNvSpPr txBox="1"/>
          <p:nvPr/>
        </p:nvSpPr>
        <p:spPr>
          <a:xfrm>
            <a:off x="3591931" y="4202155"/>
            <a:ext cx="5623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†††</a:t>
            </a:r>
            <a:endParaRPr lang="ko-KR" altLang="en-US" sz="1050" dirty="0"/>
          </a:p>
        </p:txBody>
      </p:sp>
      <p:sp>
        <p:nvSpPr>
          <p:cNvPr id="10" name="TextBox 9"/>
          <p:cNvSpPr txBox="1"/>
          <p:nvPr/>
        </p:nvSpPr>
        <p:spPr>
          <a:xfrm>
            <a:off x="825562" y="5367558"/>
            <a:ext cx="23096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* IMN-W vs IMN-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708807" y="5367558"/>
            <a:ext cx="1766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† HV vs IMN-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제목 1"/>
          <p:cNvSpPr txBox="1">
            <a:spLocks/>
          </p:cNvSpPr>
          <p:nvPr/>
        </p:nvSpPr>
        <p:spPr>
          <a:xfrm>
            <a:off x="628650" y="146724"/>
            <a:ext cx="7886700" cy="70687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</a:t>
            </a:r>
            <a:r>
              <a:rPr lang="en-US" altLang="ko-KR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표 12">
            <a:extLst>
              <a:ext uri="{FF2B5EF4-FFF2-40B4-BE49-F238E27FC236}">
                <a16:creationId xmlns="" xmlns:a16="http://schemas.microsoft.com/office/drawing/2014/main" id="{83DB44DE-C1DE-401F-A1B8-9C7A01652C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3838810"/>
              </p:ext>
            </p:extLst>
          </p:nvPr>
        </p:nvGraphicFramePr>
        <p:xfrm>
          <a:off x="4821766" y="1781360"/>
          <a:ext cx="3763433" cy="167568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148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472529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7188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03866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3990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71883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71883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186452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%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95033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HV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N-W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N-R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HV </a:t>
                      </a:r>
                    </a:p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s </a:t>
                      </a:r>
                    </a:p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N-W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HV </a:t>
                      </a:r>
                    </a:p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s </a:t>
                      </a:r>
                    </a:p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N-R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N-W </a:t>
                      </a:r>
                    </a:p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s </a:t>
                      </a:r>
                    </a:p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N-R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64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YRN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64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tRN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6.6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5.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2.5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864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nRN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7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9.5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4.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&lt;0.000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025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864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noRN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1.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2.7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1.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00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077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864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piRN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864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miRN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9.8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5.0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7.6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&lt;0.000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033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90605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내용 개체 틀 5"/>
          <p:cNvGraphicFramePr>
            <a:graphicFrameLocks noGrp="1"/>
          </p:cNvGraphicFramePr>
          <p:nvPr>
            <p:ph idx="1"/>
            <p:extLst/>
          </p:nvPr>
        </p:nvGraphicFramePr>
        <p:xfrm>
          <a:off x="4897315" y="1881553"/>
          <a:ext cx="3516925" cy="14495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99504">
                  <a:extLst>
                    <a:ext uri="{9D8B030D-6E8A-4147-A177-3AD203B41FA5}">
                      <a16:colId xmlns="" xmlns:a16="http://schemas.microsoft.com/office/drawing/2014/main" val="2435405150"/>
                    </a:ext>
                  </a:extLst>
                </a:gridCol>
                <a:gridCol w="845113">
                  <a:extLst>
                    <a:ext uri="{9D8B030D-6E8A-4147-A177-3AD203B41FA5}">
                      <a16:colId xmlns="" xmlns:a16="http://schemas.microsoft.com/office/drawing/2014/main" val="1788706953"/>
                    </a:ext>
                  </a:extLst>
                </a:gridCol>
                <a:gridCol w="1172308">
                  <a:extLst>
                    <a:ext uri="{9D8B030D-6E8A-4147-A177-3AD203B41FA5}">
                      <a16:colId xmlns="" xmlns:a16="http://schemas.microsoft.com/office/drawing/2014/main" val="3162358058"/>
                    </a:ext>
                  </a:extLst>
                </a:gridCol>
              </a:tblGrid>
              <a:tr h="33702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06343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1229-3p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7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5061883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340-3p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6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9829488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99b-5p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4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54075892"/>
                  </a:ext>
                </a:extLst>
              </a:tr>
            </a:tbl>
          </a:graphicData>
        </a:graphic>
      </p:graphicFrame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540" y="1790220"/>
            <a:ext cx="4334608" cy="435157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6173" y="2009408"/>
            <a:ext cx="1409700" cy="676275"/>
          </a:xfrm>
          <a:prstGeom prst="rect">
            <a:avLst/>
          </a:prstGeom>
        </p:spPr>
      </p:pic>
      <p:sp>
        <p:nvSpPr>
          <p:cNvPr id="7" name="제목 1"/>
          <p:cNvSpPr txBox="1">
            <a:spLocks/>
          </p:cNvSpPr>
          <p:nvPr/>
        </p:nvSpPr>
        <p:spPr>
          <a:xfrm>
            <a:off x="527540" y="406720"/>
            <a:ext cx="7886700" cy="70687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3</a:t>
            </a:r>
            <a:endParaRPr lang="ko-KR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2382715" y="1573822"/>
            <a:ext cx="1266093" cy="2163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직사각형 1"/>
          <p:cNvSpPr/>
          <p:nvPr/>
        </p:nvSpPr>
        <p:spPr>
          <a:xfrm rot="16200000">
            <a:off x="-666749" y="3365086"/>
            <a:ext cx="1890346" cy="31652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endParaRPr lang="ko-KR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1626577" y="6176343"/>
            <a:ext cx="1890346" cy="31652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-specificity</a:t>
            </a:r>
            <a:endParaRPr lang="ko-KR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265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 txBox="1">
            <a:spLocks/>
          </p:cNvSpPr>
          <p:nvPr/>
        </p:nvSpPr>
        <p:spPr>
          <a:xfrm>
            <a:off x="399273" y="412989"/>
            <a:ext cx="7886700" cy="70687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</a:t>
            </a:r>
            <a:r>
              <a:rPr lang="en-US" altLang="ko-KR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ko-KR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표 10">
            <a:extLst>
              <a:ext uri="{FF2B5EF4-FFF2-40B4-BE49-F238E27FC236}">
                <a16:creationId xmlns="" xmlns:a16="http://schemas.microsoft.com/office/drawing/2014/main" id="{CBD5CEC3-942A-4C79-BF39-325A8C678D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138923"/>
              </p:ext>
            </p:extLst>
          </p:nvPr>
        </p:nvGraphicFramePr>
        <p:xfrm>
          <a:off x="1035985" y="5573130"/>
          <a:ext cx="7412707" cy="99917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009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5710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57102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5710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5710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957102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95710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/H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N/H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N/IN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indent="0" algn="l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ure_ID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C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og2 scale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C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og2 scale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C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og2 scale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92-5p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9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5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19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94-5p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4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73</a:t>
                      </a:r>
                      <a:endParaRPr lang="en-US" altLang="ko-KR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F571FEA3-B822-4481-94FA-FAA79E77EBA4}"/>
              </a:ext>
            </a:extLst>
          </p:cNvPr>
          <p:cNvSpPr txBox="1"/>
          <p:nvPr/>
        </p:nvSpPr>
        <p:spPr>
          <a:xfrm>
            <a:off x="783089" y="12866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A4B794C3-7069-4638-8AED-43C8FBE1A429}"/>
              </a:ext>
            </a:extLst>
          </p:cNvPr>
          <p:cNvSpPr txBox="1"/>
          <p:nvPr/>
        </p:nvSpPr>
        <p:spPr>
          <a:xfrm>
            <a:off x="783089" y="508617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018" y="1625156"/>
            <a:ext cx="3239963" cy="3266342"/>
          </a:xfrm>
          <a:prstGeom prst="rect">
            <a:avLst/>
          </a:prstGeom>
        </p:spPr>
      </p:pic>
      <p:sp>
        <p:nvSpPr>
          <p:cNvPr id="3" name="타원 2"/>
          <p:cNvSpPr/>
          <p:nvPr/>
        </p:nvSpPr>
        <p:spPr>
          <a:xfrm>
            <a:off x="3657113" y="3238501"/>
            <a:ext cx="502138" cy="487994"/>
          </a:xfrm>
          <a:prstGeom prst="ellipse">
            <a:avLst/>
          </a:prstGeom>
          <a:noFill/>
          <a:ln w="28575">
            <a:solidFill>
              <a:srgbClr val="FF33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45276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/>
          </p:nvPr>
        </p:nvGraphicFramePr>
        <p:xfrm>
          <a:off x="4846320" y="1830492"/>
          <a:ext cx="4297680" cy="45411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17904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4721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43256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3190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ure </a:t>
                      </a:r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N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N-W/HV </a:t>
                      </a: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r>
                        <a:rPr lang="en-US" sz="110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nge</a:t>
                      </a:r>
                    </a:p>
                    <a:p>
                      <a:pPr marL="0" marR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g2 scale</a:t>
                      </a:r>
                    </a:p>
                  </a:txBody>
                  <a:tcPr marL="5930" marR="5930" marT="593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N-W/HV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-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4732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605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29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629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20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21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6735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50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44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44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.9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99a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3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40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7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01a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2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28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0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229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99a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99b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556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223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78889" y="92909"/>
            <a:ext cx="778622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kumimoji="0" lang="en-US" altLang="ko-KR" sz="4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 figure </a:t>
            </a:r>
            <a:r>
              <a:rPr kumimoji="0" lang="en-US" altLang="ko-KR" sz="4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5</a:t>
            </a:r>
            <a:endParaRPr kumimoji="0" lang="ko-KR" altLang="en-US" sz="4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852" y="126713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맑은 고딕" panose="020B0503020000020004" pitchFamily="50" charset="-127"/>
                <a:cs typeface="Arial" pitchFamily="34" charset="0"/>
              </a:rPr>
              <a:t>A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맑은 고딕" panose="020B0503020000020004" pitchFamily="50" charset="-127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49899" y="126713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맑은 고딕" panose="020B0503020000020004" pitchFamily="50" charset="-127"/>
                <a:cs typeface="Arial" pitchFamily="34" charset="0"/>
              </a:rPr>
              <a:t>B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맑은 고딕" panose="020B0503020000020004" pitchFamily="50" charset="-127"/>
              <a:cs typeface="Arial" pitchFamily="34" charset="0"/>
            </a:endParaRPr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78852" b="80081"/>
          <a:stretch/>
        </p:blipFill>
        <p:spPr>
          <a:xfrm>
            <a:off x="106153" y="5788056"/>
            <a:ext cx="1069820" cy="907459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/>
          <a:srcRect t="22708" b="9131"/>
          <a:stretch/>
        </p:blipFill>
        <p:spPr>
          <a:xfrm>
            <a:off x="106153" y="1792225"/>
            <a:ext cx="4529855" cy="420704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922683" y="174971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V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52270" y="1749714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MN-W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03948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직사각형 12">
            <a:extLst>
              <a:ext uri="{FF2B5EF4-FFF2-40B4-BE49-F238E27FC236}">
                <a16:creationId xmlns="" xmlns:a16="http://schemas.microsoft.com/office/drawing/2014/main" id="{E728C6D0-8A8E-4C8F-8177-31789F56E5E7}"/>
              </a:ext>
            </a:extLst>
          </p:cNvPr>
          <p:cNvSpPr/>
          <p:nvPr/>
        </p:nvSpPr>
        <p:spPr>
          <a:xfrm>
            <a:off x="1219707" y="1440278"/>
            <a:ext cx="2029481" cy="198698"/>
          </a:xfrm>
          <a:prstGeom prst="rect">
            <a:avLst/>
          </a:prstGeom>
          <a:solidFill>
            <a:srgbClr val="FF33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="" xmlns:a16="http://schemas.microsoft.com/office/drawing/2014/main" id="{2366DD27-3229-4BDC-8E66-15004A1011C5}"/>
              </a:ext>
            </a:extLst>
          </p:cNvPr>
          <p:cNvSpPr/>
          <p:nvPr/>
        </p:nvSpPr>
        <p:spPr>
          <a:xfrm>
            <a:off x="3249189" y="1440277"/>
            <a:ext cx="1003262" cy="198699"/>
          </a:xfrm>
          <a:prstGeom prst="rect">
            <a:avLst/>
          </a:prstGeom>
          <a:solidFill>
            <a:srgbClr val="33D6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TextBox 5"/>
          <p:cNvSpPr txBox="1"/>
          <p:nvPr/>
        </p:nvSpPr>
        <p:spPr>
          <a:xfrm>
            <a:off x="678889" y="98081"/>
            <a:ext cx="778622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kumimoji="0" lang="en-US" altLang="ko-KR" sz="4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 </a:t>
            </a:r>
            <a:r>
              <a:rPr kumimoji="0" lang="en-US" altLang="ko-KR" sz="4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</a:t>
            </a:r>
            <a:r>
              <a:rPr kumimoji="0" lang="en-US" altLang="ko-KR" sz="40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6</a:t>
            </a:r>
            <a:endParaRPr kumimoji="0" lang="ko-KR" altLang="en-US" sz="4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5C745D91-C8BC-47BE-8E35-7983D1D6B360}"/>
              </a:ext>
            </a:extLst>
          </p:cNvPr>
          <p:cNvSpPr txBox="1"/>
          <p:nvPr/>
        </p:nvSpPr>
        <p:spPr>
          <a:xfrm>
            <a:off x="3826694" y="168726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MN-R</a:t>
            </a:r>
            <a:endParaRPr kumimoji="0" lang="ko-KR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B6327E91-5946-4791-BE49-57EDB353EDEC}"/>
              </a:ext>
            </a:extLst>
          </p:cNvPr>
          <p:cNvSpPr txBox="1"/>
          <p:nvPr/>
        </p:nvSpPr>
        <p:spPr>
          <a:xfrm>
            <a:off x="248566" y="97453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맑은 고딕" panose="020B0503020000020004" pitchFamily="50" charset="-127"/>
                <a:cs typeface="Arial" pitchFamily="34" charset="0"/>
              </a:rPr>
              <a:t>A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맑은 고딕" panose="020B0503020000020004" pitchFamily="50" charset="-127"/>
              <a:cs typeface="Arial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0B92B28B-E438-4341-94F6-61BBC957FADA}"/>
              </a:ext>
            </a:extLst>
          </p:cNvPr>
          <p:cNvSpPr txBox="1"/>
          <p:nvPr/>
        </p:nvSpPr>
        <p:spPr>
          <a:xfrm>
            <a:off x="5017596" y="97453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맑은 고딕" panose="020B0503020000020004" pitchFamily="50" charset="-127"/>
                <a:cs typeface="Arial" pitchFamily="34" charset="0"/>
              </a:rPr>
              <a:t>B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맑은 고딕" panose="020B0503020000020004" pitchFamily="50" charset="-127"/>
              <a:cs typeface="Arial" pitchFamily="34" charset="0"/>
            </a:endParaRPr>
          </a:p>
        </p:txBody>
      </p:sp>
      <p:graphicFrame>
        <p:nvGraphicFramePr>
          <p:cNvPr id="19" name="표 18">
            <a:extLst>
              <a:ext uri="{FF2B5EF4-FFF2-40B4-BE49-F238E27FC236}">
                <a16:creationId xmlns="" xmlns:a16="http://schemas.microsoft.com/office/drawing/2014/main" id="{2CB6223F-3B28-4CA3-8BAB-035D355C9CE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195052" y="1512115"/>
          <a:ext cx="3730941" cy="45411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066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270235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7004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3190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ure </a:t>
                      </a:r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N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N-R/HV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ld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change</a:t>
                      </a:r>
                    </a:p>
                    <a:p>
                      <a:pPr marL="0" marR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g2 scale</a:t>
                      </a:r>
                    </a:p>
                  </a:txBody>
                  <a:tcPr marL="5930" marR="5930" marT="593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N-R/HV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-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45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483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285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273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6516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605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56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61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6735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84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224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5.5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875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.8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40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.8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99a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.6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48b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7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181a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.0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0b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.4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46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.0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335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7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201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-miR-625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2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930" marR="5930" marT="59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</a:tbl>
          </a:graphicData>
        </a:graphic>
      </p:graphicFrame>
      <p:pic>
        <p:nvPicPr>
          <p:cNvPr id="20" name="그림 19">
            <a:extLst>
              <a:ext uri="{FF2B5EF4-FFF2-40B4-BE49-F238E27FC236}">
                <a16:creationId xmlns="" xmlns:a16="http://schemas.microsoft.com/office/drawing/2014/main" id="{DC9348AC-14A2-47A0-9BF1-C0EBDB760C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7" t="2385" r="81199" b="79006"/>
          <a:stretch/>
        </p:blipFill>
        <p:spPr>
          <a:xfrm>
            <a:off x="629282" y="5917438"/>
            <a:ext cx="849387" cy="859536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/>
          <a:srcRect t="14507" b="5449"/>
          <a:stretch/>
        </p:blipFill>
        <p:spPr>
          <a:xfrm>
            <a:off x="104719" y="1605106"/>
            <a:ext cx="4833041" cy="431233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BCC8A4A1-63DF-4E36-8FDF-BF685372841B}"/>
              </a:ext>
            </a:extLst>
          </p:cNvPr>
          <p:cNvSpPr txBox="1"/>
          <p:nvPr/>
        </p:nvSpPr>
        <p:spPr>
          <a:xfrm>
            <a:off x="1933000" y="1354894"/>
            <a:ext cx="468398" cy="2312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V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5C745D91-C8BC-47BE-8E35-7983D1D6B360}"/>
              </a:ext>
            </a:extLst>
          </p:cNvPr>
          <p:cNvSpPr txBox="1"/>
          <p:nvPr/>
        </p:nvSpPr>
        <p:spPr>
          <a:xfrm>
            <a:off x="3384734" y="1354894"/>
            <a:ext cx="777777" cy="2312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MN-R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0845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5</TotalTime>
  <Words>320</Words>
  <Application>Microsoft Office PowerPoint</Application>
  <PresentationFormat>On-screen Show (4:3)</PresentationFormat>
  <Paragraphs>25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도경오</dc:creator>
  <cp:lastModifiedBy>Aarthi K.</cp:lastModifiedBy>
  <cp:revision>46</cp:revision>
  <dcterms:created xsi:type="dcterms:W3CDTF">2021-10-19T01:27:10Z</dcterms:created>
  <dcterms:modified xsi:type="dcterms:W3CDTF">2022-05-07T10:43:26Z</dcterms:modified>
</cp:coreProperties>
</file>